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740"/>
    <p:restoredTop sz="94694"/>
  </p:normalViewPr>
  <p:slideViewPr>
    <p:cSldViewPr snapToGrid="0">
      <p:cViewPr varScale="1">
        <p:scale>
          <a:sx n="103" d="100"/>
          <a:sy n="103" d="100"/>
        </p:scale>
        <p:origin x="1272" y="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F227D50-AC53-3085-30CB-5A2611927C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5BEA149-0C71-C0F0-1CDA-4DF681F84A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827324-4947-67B3-2D07-07817D0E7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0FA4A3-3ABD-1C44-D9DA-0709AD671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1DBC4F-2E59-6576-61C9-AB35CD9A06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168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D020DE-2740-34AD-11FC-2E8E0711D7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8F1E548-EAE5-7A9E-21EE-61B17D7919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2B85526-A1CB-A741-0078-866E83ADD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2BC45AB-C43F-4B24-A41D-41E23835EE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63F2D9-F10F-FE20-33BD-77141573F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0861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5400CBF-9C3A-6FBD-30B2-B2B4D003DB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5783B41-73FA-636A-9592-FE6FDBD53B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3A3CAC8-3177-BAF0-1DB5-FB32CAB0F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5FB130-B0E2-89EF-D8BD-3C706FEF2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D6DB068-9517-6B6B-418E-4F9F54BF2E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082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7E7243-240D-834C-C016-B886C82F4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EDFF689-5FAC-9E98-3211-2E3FDA6D59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B69BAA9-FBB9-6DCC-14B5-E2AD79C02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86968E-678F-B4EC-70FF-4C30F75B2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6AB486-B570-3547-C3CB-A4B67ABB8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0599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09C10F-A2EE-90D9-4669-95ACEF6682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36916D-254D-256A-1324-C45B52177E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AA95A8-B452-CDBA-B5E1-C059D8BC5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59A93AD-AC62-BC17-B335-EFFF78B40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B423A3-9F72-D360-AE39-CCC18BA32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245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AD8ADD-6965-51AA-5348-FF202E07C3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BF6C5BA-A2A5-A1E0-88C2-3B26A10BC6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EC4E2B9-0135-C2FF-5B4B-110709C32B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CEC66F3-B573-2629-6BD7-70A1B3FF5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07819D-55F5-E4CA-AAFF-9271175DE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E80812A-8C14-4325-2637-C260E99ED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0300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3AC672-0EA6-6FC4-E87B-EA1B7E34B1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28AC2AA-BCAD-F18B-C0E2-C6BA75AFC6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5770A24-A352-B975-CB10-2611FD719F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573C239-A969-6BFD-62D1-D4DAED3E8C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1BD6CBE-621C-4D32-AC17-4E7833B4F6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CE7BB31-3B25-8D98-3692-978E8BBDF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8E7CC15-63DE-F634-674C-245E157E3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2D5376B-F273-7657-64F1-C2C33FB39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7884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4961D4-C1FF-4EAF-13FA-2079739A3C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636818A-100F-C261-B116-4CF49A0071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9FA8D4C-F3A5-46D2-5BAC-0242121A4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C11189C-C0DA-1045-E912-805DC38A3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3900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F4C9674-4104-2B0D-395D-71D40A4AED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794782F-99A7-F74E-E5A9-D24C124E8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6721226-17A5-0DA9-1EBA-74419722F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550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4BCDD5-E3B2-57E4-77C3-161B562EDC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EF672E9-6668-EDE4-B5E3-E1759FE13E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7800832-8C1E-08CF-2CD2-331015FAAB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E126DFD-EDC7-C61B-4EB5-1B8A06CFA6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5958A0C-EAA2-E6A1-DF60-0CA00C7AE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D0C4069-E30B-20A5-FF8B-6A5870FEB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654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E4CA11-B388-76BF-7332-53F3427592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B8A1DDA-6FCE-7005-4E6F-E8EEB9D93C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8F301F8-AE0D-6F11-70FA-C8F2F5DB4B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AC62B7A-4997-E10A-630C-6A2FD47D3F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55A88C8-7AF6-C9BE-904C-869B3E768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972B22A-72D7-C9F6-E080-506FFC50D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246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28C8770-DC55-B92B-B805-7E5ECA7CB9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822A751-3E43-60A3-0241-EE7ABAAA8A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F6191E5-FCF2-422F-0D2F-8EEBE6E8CC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83F637-92B0-3340-9AA1-C58EB1FEB80D}" type="datetimeFigureOut">
              <a:rPr kumimoji="1" lang="ja-JP" altLang="en-US" smtClean="0"/>
              <a:t>2025/6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3BEB12-0419-1BC8-C4BC-CB7294112C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372E03-0BBD-17A3-311F-3F7F98102A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808CFC-44FB-394A-AA0A-F7EB09CB89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4567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08FBE78-C276-93ED-32B9-C867BB812FE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240" t="12353" r="10027" b="43553"/>
          <a:stretch/>
        </p:blipFill>
        <p:spPr>
          <a:xfrm rot="5400000">
            <a:off x="3351849" y="1530646"/>
            <a:ext cx="2902353" cy="1534877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4825222-03EB-0C27-40CE-D137ED9DB1C3}"/>
              </a:ext>
            </a:extLst>
          </p:cNvPr>
          <p:cNvSpPr txBox="1"/>
          <p:nvPr/>
        </p:nvSpPr>
        <p:spPr>
          <a:xfrm>
            <a:off x="4445881" y="3815480"/>
            <a:ext cx="615553" cy="219561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ontrol (</a:t>
            </a:r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pplication of sterilized water)</a:t>
            </a:r>
            <a:endParaRPr kumimoji="1" lang="en-US" altLang="ja-JP" sz="1400" dirty="0">
              <a:solidFill>
                <a:srgbClr val="FF0000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A55B36D-5D7D-2613-6795-14B862765F7D}"/>
              </a:ext>
            </a:extLst>
          </p:cNvPr>
          <p:cNvSpPr txBox="1"/>
          <p:nvPr/>
        </p:nvSpPr>
        <p:spPr>
          <a:xfrm>
            <a:off x="5037299" y="3815481"/>
            <a:ext cx="615553" cy="222836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tandard mix consisting of </a:t>
            </a:r>
            <a:r>
              <a:rPr kumimoji="1" lang="en-US" altLang="ja-JP" sz="1400" kern="1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eramides NS, AS, and NP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BDE64B9-27BE-9C65-905E-B6B7126FF114}"/>
              </a:ext>
            </a:extLst>
          </p:cNvPr>
          <p:cNvSpPr txBox="1"/>
          <p:nvPr/>
        </p:nvSpPr>
        <p:spPr>
          <a:xfrm>
            <a:off x="3925982" y="3823788"/>
            <a:ext cx="615553" cy="217899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pplication of ultrafine water droplets</a:t>
            </a:r>
            <a:endParaRPr kumimoji="1" lang="ja-JP" altLang="en-US" sz="140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5FFA60B-2894-B433-6ECF-98F9C23B6279}"/>
              </a:ext>
            </a:extLst>
          </p:cNvPr>
          <p:cNvSpPr txBox="1"/>
          <p:nvPr/>
        </p:nvSpPr>
        <p:spPr>
          <a:xfrm>
            <a:off x="5645554" y="2494780"/>
            <a:ext cx="1696752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ja-JP" altLang="en-US" sz="160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←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Ceramide NS </a:t>
            </a:r>
            <a:endParaRPr kumimoji="1" lang="en-US" altLang="ja-JP" sz="16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866E2A-29E9-2E20-8F16-587B3C11D0BA}"/>
              </a:ext>
            </a:extLst>
          </p:cNvPr>
          <p:cNvSpPr txBox="1"/>
          <p:nvPr/>
        </p:nvSpPr>
        <p:spPr>
          <a:xfrm>
            <a:off x="5638638" y="2833334"/>
            <a:ext cx="1678006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ja-JP" altLang="en-US" sz="160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←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Ceramide AS </a:t>
            </a:r>
            <a:endParaRPr kumimoji="1" lang="en-US" altLang="ja-JP" sz="16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6255FE8-3A33-1963-0AA2-5A0ECA72E8AB}"/>
              </a:ext>
            </a:extLst>
          </p:cNvPr>
          <p:cNvSpPr txBox="1"/>
          <p:nvPr/>
        </p:nvSpPr>
        <p:spPr>
          <a:xfrm>
            <a:off x="5645554" y="3096368"/>
            <a:ext cx="2101445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ja-JP" altLang="en-US" sz="160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←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Ceramide NP </a:t>
            </a:r>
            <a:endParaRPr kumimoji="1" lang="en-US" altLang="ja-JP" sz="16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B63156F-EABD-605A-3B3F-6B0AF5957F7B}"/>
              </a:ext>
            </a:extLst>
          </p:cNvPr>
          <p:cNvSpPr txBox="1"/>
          <p:nvPr/>
        </p:nvSpPr>
        <p:spPr>
          <a:xfrm>
            <a:off x="87696" y="0"/>
            <a:ext cx="2345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B7BF030-24A3-1139-8DE2-B963766BF965}"/>
              </a:ext>
            </a:extLst>
          </p:cNvPr>
          <p:cNvSpPr txBox="1"/>
          <p:nvPr/>
        </p:nvSpPr>
        <p:spPr>
          <a:xfrm>
            <a:off x="72202" y="6434212"/>
            <a:ext cx="8938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HPTLC ceramide image of the 3D skin model after the application of ultrafine water droplets.</a:t>
            </a:r>
            <a:r>
              <a:rPr lang="ja-JP" altLang="ja-JP">
                <a:effectLst/>
              </a:rPr>
              <a:t> 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1114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51</Words>
  <Application>Microsoft Macintosh PowerPoint</Application>
  <PresentationFormat>ワイド画面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aki Todo</dc:creator>
  <cp:lastModifiedBy>Hiroaki Todo</cp:lastModifiedBy>
  <cp:revision>7</cp:revision>
  <dcterms:created xsi:type="dcterms:W3CDTF">2025-03-06T08:58:55Z</dcterms:created>
  <dcterms:modified xsi:type="dcterms:W3CDTF">2025-06-07T04:00:37Z</dcterms:modified>
</cp:coreProperties>
</file>